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45" d="100"/>
          <a:sy n="45" d="100"/>
        </p:scale>
        <p:origin x="1544" y="44"/>
      </p:cViewPr>
      <p:guideLst>
        <p:guide orient="horz" pos="307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0629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91191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0951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251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8853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4313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06600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66569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56280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7573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445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74312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0B7AB34D-42DD-019A-A4D7-EA06205C68E2}"/>
              </a:ext>
            </a:extLst>
          </p:cNvPr>
          <p:cNvGrpSpPr/>
          <p:nvPr/>
        </p:nvGrpSpPr>
        <p:grpSpPr>
          <a:xfrm>
            <a:off x="1239838" y="1471366"/>
            <a:ext cx="1879348" cy="2460986"/>
            <a:chOff x="773398" y="3632960"/>
            <a:chExt cx="2248681" cy="2671107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108CBE0-F1AD-1B92-769B-1FFB5C523198}"/>
                </a:ext>
              </a:extLst>
            </p:cNvPr>
            <p:cNvGrpSpPr/>
            <p:nvPr/>
          </p:nvGrpSpPr>
          <p:grpSpPr>
            <a:xfrm>
              <a:off x="773398" y="4093396"/>
              <a:ext cx="1267605" cy="2210671"/>
              <a:chOff x="2194067" y="1397156"/>
              <a:chExt cx="816411" cy="2221638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04878809-75D0-8F43-4102-513D72CBD8C6}"/>
                  </a:ext>
                </a:extLst>
              </p:cNvPr>
              <p:cNvPicPr/>
              <p:nvPr/>
            </p:nvPicPr>
            <p:blipFill rotWithShape="1">
              <a:blip r:embed="rId2" cstate="print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153" t="31502" r="40964" b="53396"/>
              <a:stretch>
                <a:fillRect/>
              </a:stretch>
            </p:blipFill>
            <p:spPr>
              <a:xfrm>
                <a:off x="2194067" y="2165766"/>
                <a:ext cx="816411" cy="6858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E15623C5-5C03-1C11-91EC-57B0C658833D}"/>
                  </a:ext>
                </a:extLst>
              </p:cNvPr>
              <p:cNvPicPr/>
              <p:nvPr/>
            </p:nvPicPr>
            <p:blipFill rotWithShape="1">
              <a:blip r:embed="rId3" cstate="print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127" t="53958" r="31661" b="31961"/>
              <a:stretch>
                <a:fillRect/>
              </a:stretch>
            </p:blipFill>
            <p:spPr>
              <a:xfrm>
                <a:off x="2194067" y="2932994"/>
                <a:ext cx="816178" cy="6858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5CA5F5BA-7D88-0D96-21FC-2306338C5F54}"/>
                  </a:ext>
                </a:extLst>
              </p:cNvPr>
              <p:cNvPicPr/>
              <p:nvPr/>
            </p:nvPicPr>
            <p:blipFill rotWithShape="1">
              <a:blip r:embed="rId4" cstate="print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172" t="38915" r="23448" b="40324"/>
              <a:stretch>
                <a:fillRect/>
              </a:stretch>
            </p:blipFill>
            <p:spPr>
              <a:xfrm>
                <a:off x="2195673" y="1397156"/>
                <a:ext cx="814572" cy="683318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71B428A-343B-B32D-329F-978FB7E73022}"/>
                </a:ext>
              </a:extLst>
            </p:cNvPr>
            <p:cNvSpPr txBox="1"/>
            <p:nvPr/>
          </p:nvSpPr>
          <p:spPr>
            <a:xfrm rot="18969520">
              <a:off x="1389875" y="3636889"/>
              <a:ext cx="1125201" cy="2839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Msi2 O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A3D0564-F152-C54F-A326-9ECEBFFDEFF7}"/>
                </a:ext>
              </a:extLst>
            </p:cNvPr>
            <p:cNvSpPr txBox="1"/>
            <p:nvPr/>
          </p:nvSpPr>
          <p:spPr>
            <a:xfrm rot="18969520">
              <a:off x="785894" y="3632960"/>
              <a:ext cx="1125201" cy="283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EV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D3620FF-7EC4-E3AE-13AA-37C0DDEF5C18}"/>
                </a:ext>
              </a:extLst>
            </p:cNvPr>
            <p:cNvSpPr txBox="1"/>
            <p:nvPr/>
          </p:nvSpPr>
          <p:spPr>
            <a:xfrm>
              <a:off x="2005191" y="4440576"/>
              <a:ext cx="1016888" cy="2839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Msi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8531973-B42C-B34E-B126-30881E5E4383}"/>
                </a:ext>
              </a:extLst>
            </p:cNvPr>
            <p:cNvSpPr txBox="1"/>
            <p:nvPr/>
          </p:nvSpPr>
          <p:spPr>
            <a:xfrm>
              <a:off x="1981029" y="5185738"/>
              <a:ext cx="1006389" cy="2839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APAF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FFB35C0-279B-7160-00C3-731A05DEC798}"/>
                </a:ext>
              </a:extLst>
            </p:cNvPr>
            <p:cNvSpPr txBox="1"/>
            <p:nvPr/>
          </p:nvSpPr>
          <p:spPr>
            <a:xfrm>
              <a:off x="1993534" y="5893160"/>
              <a:ext cx="920384" cy="2839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Tubulin</a:t>
              </a:r>
            </a:p>
          </p:txBody>
        </p:sp>
      </p:grpSp>
      <p:pic>
        <p:nvPicPr>
          <p:cNvPr id="16" name="Picture 15">
            <a:extLst>
              <a:ext uri="{FF2B5EF4-FFF2-40B4-BE49-F238E27FC236}">
                <a16:creationId xmlns:a16="http://schemas.microsoft.com/office/drawing/2014/main" id="{B64BA46E-A972-6FFF-3A05-EBF6BCEF174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529" r="3268"/>
          <a:stretch>
            <a:fillRect/>
          </a:stretch>
        </p:blipFill>
        <p:spPr>
          <a:xfrm>
            <a:off x="3429000" y="1316998"/>
            <a:ext cx="3160338" cy="261535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FF7592C2-5904-A8A9-540F-2409F5331922}"/>
              </a:ext>
            </a:extLst>
          </p:cNvPr>
          <p:cNvSpPr txBox="1"/>
          <p:nvPr/>
        </p:nvSpPr>
        <p:spPr>
          <a:xfrm>
            <a:off x="753067" y="1359561"/>
            <a:ext cx="414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Bell MT" panose="02020503060305020303" pitchFamily="18" charset="0"/>
              </a:rPr>
              <a:t>A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766AB7B-63A3-B229-F63C-FBA189417C43}"/>
              </a:ext>
            </a:extLst>
          </p:cNvPr>
          <p:cNvSpPr txBox="1"/>
          <p:nvPr/>
        </p:nvSpPr>
        <p:spPr>
          <a:xfrm>
            <a:off x="3221618" y="1287292"/>
            <a:ext cx="414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Bell MT" panose="02020503060305020303" pitchFamily="18" charset="0"/>
              </a:rPr>
              <a:t>B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DC11176-88ED-9A21-914F-52B16904957F}"/>
              </a:ext>
            </a:extLst>
          </p:cNvPr>
          <p:cNvSpPr txBox="1"/>
          <p:nvPr/>
        </p:nvSpPr>
        <p:spPr>
          <a:xfrm>
            <a:off x="561860" y="4824232"/>
            <a:ext cx="5811398" cy="17247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 Fig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Msi2 overexpression causes decrease in the APAF1 protein levels. 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peGFP.C1 EV and peGFP.C1 Msi2 constructs were overexpressed in N2a cells and the protein levels of APAF1 was analyzed by western blotting.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(A)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Western blot showing protein levels of APAF1 upon Msi2 overexpression. (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ar graph representing the relative quantitation of the Msi2 and APAF protein normalized to Tubulin levels from three independent Western blots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674D0ED-7F0E-8AA3-C952-09678090DBF8}"/>
              </a:ext>
            </a:extLst>
          </p:cNvPr>
          <p:cNvSpPr txBox="1"/>
          <p:nvPr/>
        </p:nvSpPr>
        <p:spPr>
          <a:xfrm>
            <a:off x="5711986" y="50521"/>
            <a:ext cx="11797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I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ikwad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</a:t>
            </a:r>
          </a:p>
        </p:txBody>
      </p:sp>
    </p:spTree>
    <p:extLst>
      <p:ext uri="{BB962C8B-B14F-4D97-AF65-F5344CB8AC3E}">
        <p14:creationId xmlns:p14="http://schemas.microsoft.com/office/powerpoint/2010/main" val="30194183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</TotalTime>
  <Words>93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Bell MT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ina gaikwad</dc:creator>
  <cp:lastModifiedBy>comp support</cp:lastModifiedBy>
  <cp:revision>24</cp:revision>
  <dcterms:created xsi:type="dcterms:W3CDTF">2022-09-05T06:06:19Z</dcterms:created>
  <dcterms:modified xsi:type="dcterms:W3CDTF">2024-12-01T12:27:27Z</dcterms:modified>
</cp:coreProperties>
</file>